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75" d="100"/>
          <a:sy n="75" d="100"/>
        </p:scale>
        <p:origin x="1694" y="36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Users\saueno\Documents\sugi\Fu-Jin\PlosOne\submission202003\PACE_download\submission2020March\revision\ngsRelate-rsgcc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3661420523490219E-2"/>
          <c:y val="4.0104473324464235E-2"/>
          <c:w val="0.85945690825823429"/>
          <c:h val="0.64818485747988663"/>
        </c:manualLayout>
      </c:layout>
      <c:scatterChart>
        <c:scatterStyle val="lineMarker"/>
        <c:varyColors val="0"/>
        <c:ser>
          <c:idx val="0"/>
          <c:order val="0"/>
          <c:tx>
            <c:strRef>
              <c:f>ngsRelate2!$L$21</c:f>
              <c:strCache>
                <c:ptCount val="1"/>
                <c:pt idx="0">
                  <c:v>MF-MF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ngsRelate2!$D$22:$D$66</c:f>
              <c:numCache>
                <c:formatCode>General</c:formatCode>
                <c:ptCount val="45"/>
                <c:pt idx="0">
                  <c:v>0.46544200000000002</c:v>
                </c:pt>
                <c:pt idx="1">
                  <c:v>0.41791499999999998</c:v>
                </c:pt>
                <c:pt idx="2">
                  <c:v>0.39836300000000002</c:v>
                </c:pt>
                <c:pt idx="3">
                  <c:v>0.418236</c:v>
                </c:pt>
                <c:pt idx="4">
                  <c:v>0.42063200000000001</c:v>
                </c:pt>
                <c:pt idx="5">
                  <c:v>0.50950200000000001</c:v>
                </c:pt>
                <c:pt idx="6">
                  <c:v>0.26186300000000001</c:v>
                </c:pt>
                <c:pt idx="7">
                  <c:v>0.42806300000000003</c:v>
                </c:pt>
                <c:pt idx="8">
                  <c:v>0.51772600000000002</c:v>
                </c:pt>
                <c:pt idx="9">
                  <c:v>0.61347399999999996</c:v>
                </c:pt>
                <c:pt idx="10">
                  <c:v>0.50597400000000003</c:v>
                </c:pt>
                <c:pt idx="11">
                  <c:v>0.50970899999999997</c:v>
                </c:pt>
                <c:pt idx="12">
                  <c:v>0.51433200000000001</c:v>
                </c:pt>
                <c:pt idx="13">
                  <c:v>0.52567200000000003</c:v>
                </c:pt>
                <c:pt idx="14">
                  <c:v>0.29619699999999999</c:v>
                </c:pt>
                <c:pt idx="15">
                  <c:v>0.51184700000000005</c:v>
                </c:pt>
                <c:pt idx="16">
                  <c:v>0.47953499999999999</c:v>
                </c:pt>
                <c:pt idx="17">
                  <c:v>0.60518000000000005</c:v>
                </c:pt>
                <c:pt idx="18">
                  <c:v>0.57027600000000001</c:v>
                </c:pt>
                <c:pt idx="19">
                  <c:v>0.57694299999999998</c:v>
                </c:pt>
                <c:pt idx="20">
                  <c:v>0.457457</c:v>
                </c:pt>
                <c:pt idx="21">
                  <c:v>0.34354699999999999</c:v>
                </c:pt>
                <c:pt idx="22">
                  <c:v>0.55021399999999998</c:v>
                </c:pt>
                <c:pt idx="23">
                  <c:v>0.423983</c:v>
                </c:pt>
                <c:pt idx="24">
                  <c:v>0.78660600000000003</c:v>
                </c:pt>
                <c:pt idx="25">
                  <c:v>0.79294699999999996</c:v>
                </c:pt>
                <c:pt idx="26">
                  <c:v>0.43724299999999999</c:v>
                </c:pt>
                <c:pt idx="27">
                  <c:v>0.47153699999999998</c:v>
                </c:pt>
                <c:pt idx="28">
                  <c:v>0.72457000000000005</c:v>
                </c:pt>
                <c:pt idx="29">
                  <c:v>0.39781</c:v>
                </c:pt>
                <c:pt idx="30">
                  <c:v>0.92727599999999999</c:v>
                </c:pt>
                <c:pt idx="31">
                  <c:v>0.46523900000000001</c:v>
                </c:pt>
                <c:pt idx="32">
                  <c:v>0.45355600000000001</c:v>
                </c:pt>
                <c:pt idx="33">
                  <c:v>0.75563599999999997</c:v>
                </c:pt>
                <c:pt idx="34">
                  <c:v>0.42865999999999999</c:v>
                </c:pt>
                <c:pt idx="35">
                  <c:v>0.46783000000000002</c:v>
                </c:pt>
                <c:pt idx="36">
                  <c:v>0.45271299999999998</c:v>
                </c:pt>
                <c:pt idx="37">
                  <c:v>0.76128200000000001</c:v>
                </c:pt>
                <c:pt idx="38">
                  <c:v>0.425429</c:v>
                </c:pt>
                <c:pt idx="39">
                  <c:v>0.28205599999999997</c:v>
                </c:pt>
                <c:pt idx="40">
                  <c:v>0.47584599999999999</c:v>
                </c:pt>
                <c:pt idx="41">
                  <c:v>0.52213799999999999</c:v>
                </c:pt>
                <c:pt idx="42">
                  <c:v>0.56401800000000002</c:v>
                </c:pt>
                <c:pt idx="43">
                  <c:v>0.26060699999999998</c:v>
                </c:pt>
                <c:pt idx="44">
                  <c:v>0.43262899999999999</c:v>
                </c:pt>
              </c:numCache>
            </c:numRef>
          </c:xVal>
          <c:yVal>
            <c:numRef>
              <c:f>ngsRelate2!$L$22:$L$66</c:f>
              <c:numCache>
                <c:formatCode>General</c:formatCode>
                <c:ptCount val="45"/>
                <c:pt idx="17">
                  <c:v>0.934605044</c:v>
                </c:pt>
                <c:pt idx="18">
                  <c:v>0.91216401999999996</c:v>
                </c:pt>
                <c:pt idx="19">
                  <c:v>0.91770004100000002</c:v>
                </c:pt>
                <c:pt idx="21">
                  <c:v>0.89019344099999997</c:v>
                </c:pt>
                <c:pt idx="22">
                  <c:v>0.88254824300000001</c:v>
                </c:pt>
                <c:pt idx="24">
                  <c:v>0.92247777799999997</c:v>
                </c:pt>
                <c:pt idx="25">
                  <c:v>0.91816407099999997</c:v>
                </c:pt>
                <c:pt idx="27">
                  <c:v>0.87295381500000002</c:v>
                </c:pt>
                <c:pt idx="28">
                  <c:v>0.84920857199999999</c:v>
                </c:pt>
                <c:pt idx="30">
                  <c:v>0.98994298300000005</c:v>
                </c:pt>
                <c:pt idx="32">
                  <c:v>0.92980870400000004</c:v>
                </c:pt>
                <c:pt idx="33">
                  <c:v>0.90223068699999998</c:v>
                </c:pt>
                <c:pt idx="36">
                  <c:v>0.93622486000000005</c:v>
                </c:pt>
                <c:pt idx="37">
                  <c:v>0.924286838</c:v>
                </c:pt>
                <c:pt idx="42">
                  <c:v>0.89587795999999997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ngsRelate2!$M$21</c:f>
              <c:strCache>
                <c:ptCount val="1"/>
                <c:pt idx="0">
                  <c:v>MF-IBL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ngsRelate2!$D$22:$D$66</c:f>
              <c:numCache>
                <c:formatCode>General</c:formatCode>
                <c:ptCount val="45"/>
                <c:pt idx="0">
                  <c:v>0.46544200000000002</c:v>
                </c:pt>
                <c:pt idx="1">
                  <c:v>0.41791499999999998</c:v>
                </c:pt>
                <c:pt idx="2">
                  <c:v>0.39836300000000002</c:v>
                </c:pt>
                <c:pt idx="3">
                  <c:v>0.418236</c:v>
                </c:pt>
                <c:pt idx="4">
                  <c:v>0.42063200000000001</c:v>
                </c:pt>
                <c:pt idx="5">
                  <c:v>0.50950200000000001</c:v>
                </c:pt>
                <c:pt idx="6">
                  <c:v>0.26186300000000001</c:v>
                </c:pt>
                <c:pt idx="7">
                  <c:v>0.42806300000000003</c:v>
                </c:pt>
                <c:pt idx="8">
                  <c:v>0.51772600000000002</c:v>
                </c:pt>
                <c:pt idx="9">
                  <c:v>0.61347399999999996</c:v>
                </c:pt>
                <c:pt idx="10">
                  <c:v>0.50597400000000003</c:v>
                </c:pt>
                <c:pt idx="11">
                  <c:v>0.50970899999999997</c:v>
                </c:pt>
                <c:pt idx="12">
                  <c:v>0.51433200000000001</c:v>
                </c:pt>
                <c:pt idx="13">
                  <c:v>0.52567200000000003</c:v>
                </c:pt>
                <c:pt idx="14">
                  <c:v>0.29619699999999999</c:v>
                </c:pt>
                <c:pt idx="15">
                  <c:v>0.51184700000000005</c:v>
                </c:pt>
                <c:pt idx="16">
                  <c:v>0.47953499999999999</c:v>
                </c:pt>
                <c:pt idx="17">
                  <c:v>0.60518000000000005</c:v>
                </c:pt>
                <c:pt idx="18">
                  <c:v>0.57027600000000001</c:v>
                </c:pt>
                <c:pt idx="19">
                  <c:v>0.57694299999999998</c:v>
                </c:pt>
                <c:pt idx="20">
                  <c:v>0.457457</c:v>
                </c:pt>
                <c:pt idx="21">
                  <c:v>0.34354699999999999</c:v>
                </c:pt>
                <c:pt idx="22">
                  <c:v>0.55021399999999998</c:v>
                </c:pt>
                <c:pt idx="23">
                  <c:v>0.423983</c:v>
                </c:pt>
                <c:pt idx="24">
                  <c:v>0.78660600000000003</c:v>
                </c:pt>
                <c:pt idx="25">
                  <c:v>0.79294699999999996</c:v>
                </c:pt>
                <c:pt idx="26">
                  <c:v>0.43724299999999999</c:v>
                </c:pt>
                <c:pt idx="27">
                  <c:v>0.47153699999999998</c:v>
                </c:pt>
                <c:pt idx="28">
                  <c:v>0.72457000000000005</c:v>
                </c:pt>
                <c:pt idx="29">
                  <c:v>0.39781</c:v>
                </c:pt>
                <c:pt idx="30">
                  <c:v>0.92727599999999999</c:v>
                </c:pt>
                <c:pt idx="31">
                  <c:v>0.46523900000000001</c:v>
                </c:pt>
                <c:pt idx="32">
                  <c:v>0.45355600000000001</c:v>
                </c:pt>
                <c:pt idx="33">
                  <c:v>0.75563599999999997</c:v>
                </c:pt>
                <c:pt idx="34">
                  <c:v>0.42865999999999999</c:v>
                </c:pt>
                <c:pt idx="35">
                  <c:v>0.46783000000000002</c:v>
                </c:pt>
                <c:pt idx="36">
                  <c:v>0.45271299999999998</c:v>
                </c:pt>
                <c:pt idx="37">
                  <c:v>0.76128200000000001</c:v>
                </c:pt>
                <c:pt idx="38">
                  <c:v>0.425429</c:v>
                </c:pt>
                <c:pt idx="39">
                  <c:v>0.28205599999999997</c:v>
                </c:pt>
                <c:pt idx="40">
                  <c:v>0.47584599999999999</c:v>
                </c:pt>
                <c:pt idx="41">
                  <c:v>0.52213799999999999</c:v>
                </c:pt>
                <c:pt idx="42">
                  <c:v>0.56401800000000002</c:v>
                </c:pt>
                <c:pt idx="43">
                  <c:v>0.26060699999999998</c:v>
                </c:pt>
                <c:pt idx="44">
                  <c:v>0.43262899999999999</c:v>
                </c:pt>
              </c:numCache>
            </c:numRef>
          </c:xVal>
          <c:yVal>
            <c:numRef>
              <c:f>ngsRelate2!$M$22:$M$66</c:f>
              <c:numCache>
                <c:formatCode>General</c:formatCode>
                <c:ptCount val="45"/>
                <c:pt idx="1">
                  <c:v>0.53670057500000001</c:v>
                </c:pt>
                <c:pt idx="2">
                  <c:v>0.39836983500000001</c:v>
                </c:pt>
                <c:pt idx="3">
                  <c:v>0.49025931499999997</c:v>
                </c:pt>
                <c:pt idx="4">
                  <c:v>0.51109535100000003</c:v>
                </c:pt>
                <c:pt idx="6">
                  <c:v>0.56124477900000003</c:v>
                </c:pt>
                <c:pt idx="7">
                  <c:v>0.52909191099999997</c:v>
                </c:pt>
                <c:pt idx="23">
                  <c:v>0.51961779200000002</c:v>
                </c:pt>
                <c:pt idx="29">
                  <c:v>0.408922177</c:v>
                </c:pt>
                <c:pt idx="34">
                  <c:v>0.55356984399999998</c:v>
                </c:pt>
                <c:pt idx="38">
                  <c:v>0.56718431199999997</c:v>
                </c:pt>
                <c:pt idx="43">
                  <c:v>0.605177619</c:v>
                </c:pt>
                <c:pt idx="44">
                  <c:v>0.57685321199999995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ngsRelate2!$N$21</c:f>
              <c:strCache>
                <c:ptCount val="1"/>
                <c:pt idx="0">
                  <c:v>MF-MFIBL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ngsRelate2!$D$22:$D$66</c:f>
              <c:numCache>
                <c:formatCode>General</c:formatCode>
                <c:ptCount val="45"/>
                <c:pt idx="0">
                  <c:v>0.46544200000000002</c:v>
                </c:pt>
                <c:pt idx="1">
                  <c:v>0.41791499999999998</c:v>
                </c:pt>
                <c:pt idx="2">
                  <c:v>0.39836300000000002</c:v>
                </c:pt>
                <c:pt idx="3">
                  <c:v>0.418236</c:v>
                </c:pt>
                <c:pt idx="4">
                  <c:v>0.42063200000000001</c:v>
                </c:pt>
                <c:pt idx="5">
                  <c:v>0.50950200000000001</c:v>
                </c:pt>
                <c:pt idx="6">
                  <c:v>0.26186300000000001</c:v>
                </c:pt>
                <c:pt idx="7">
                  <c:v>0.42806300000000003</c:v>
                </c:pt>
                <c:pt idx="8">
                  <c:v>0.51772600000000002</c:v>
                </c:pt>
                <c:pt idx="9">
                  <c:v>0.61347399999999996</c:v>
                </c:pt>
                <c:pt idx="10">
                  <c:v>0.50597400000000003</c:v>
                </c:pt>
                <c:pt idx="11">
                  <c:v>0.50970899999999997</c:v>
                </c:pt>
                <c:pt idx="12">
                  <c:v>0.51433200000000001</c:v>
                </c:pt>
                <c:pt idx="13">
                  <c:v>0.52567200000000003</c:v>
                </c:pt>
                <c:pt idx="14">
                  <c:v>0.29619699999999999</c:v>
                </c:pt>
                <c:pt idx="15">
                  <c:v>0.51184700000000005</c:v>
                </c:pt>
                <c:pt idx="16">
                  <c:v>0.47953499999999999</c:v>
                </c:pt>
                <c:pt idx="17">
                  <c:v>0.60518000000000005</c:v>
                </c:pt>
                <c:pt idx="18">
                  <c:v>0.57027600000000001</c:v>
                </c:pt>
                <c:pt idx="19">
                  <c:v>0.57694299999999998</c:v>
                </c:pt>
                <c:pt idx="20">
                  <c:v>0.457457</c:v>
                </c:pt>
                <c:pt idx="21">
                  <c:v>0.34354699999999999</c:v>
                </c:pt>
                <c:pt idx="22">
                  <c:v>0.55021399999999998</c:v>
                </c:pt>
                <c:pt idx="23">
                  <c:v>0.423983</c:v>
                </c:pt>
                <c:pt idx="24">
                  <c:v>0.78660600000000003</c:v>
                </c:pt>
                <c:pt idx="25">
                  <c:v>0.79294699999999996</c:v>
                </c:pt>
                <c:pt idx="26">
                  <c:v>0.43724299999999999</c:v>
                </c:pt>
                <c:pt idx="27">
                  <c:v>0.47153699999999998</c:v>
                </c:pt>
                <c:pt idx="28">
                  <c:v>0.72457000000000005</c:v>
                </c:pt>
                <c:pt idx="29">
                  <c:v>0.39781</c:v>
                </c:pt>
                <c:pt idx="30">
                  <c:v>0.92727599999999999</c:v>
                </c:pt>
                <c:pt idx="31">
                  <c:v>0.46523900000000001</c:v>
                </c:pt>
                <c:pt idx="32">
                  <c:v>0.45355600000000001</c:v>
                </c:pt>
                <c:pt idx="33">
                  <c:v>0.75563599999999997</c:v>
                </c:pt>
                <c:pt idx="34">
                  <c:v>0.42865999999999999</c:v>
                </c:pt>
                <c:pt idx="35">
                  <c:v>0.46783000000000002</c:v>
                </c:pt>
                <c:pt idx="36">
                  <c:v>0.45271299999999998</c:v>
                </c:pt>
                <c:pt idx="37">
                  <c:v>0.76128200000000001</c:v>
                </c:pt>
                <c:pt idx="38">
                  <c:v>0.425429</c:v>
                </c:pt>
                <c:pt idx="39">
                  <c:v>0.28205599999999997</c:v>
                </c:pt>
                <c:pt idx="40">
                  <c:v>0.47584599999999999</c:v>
                </c:pt>
                <c:pt idx="41">
                  <c:v>0.52213799999999999</c:v>
                </c:pt>
                <c:pt idx="42">
                  <c:v>0.56401800000000002</c:v>
                </c:pt>
                <c:pt idx="43">
                  <c:v>0.26060699999999998</c:v>
                </c:pt>
                <c:pt idx="44">
                  <c:v>0.43262899999999999</c:v>
                </c:pt>
              </c:numCache>
            </c:numRef>
          </c:xVal>
          <c:yVal>
            <c:numRef>
              <c:f>ngsRelate2!$N$22:$N$66</c:f>
              <c:numCache>
                <c:formatCode>General</c:formatCode>
                <c:ptCount val="45"/>
                <c:pt idx="9">
                  <c:v>0.73393653800000003</c:v>
                </c:pt>
                <c:pt idx="10">
                  <c:v>0.62132939300000001</c:v>
                </c:pt>
                <c:pt idx="11">
                  <c:v>0.70832983000000005</c:v>
                </c:pt>
                <c:pt idx="12">
                  <c:v>0.71719710800000003</c:v>
                </c:pt>
                <c:pt idx="14">
                  <c:v>0.73366683799999999</c:v>
                </c:pt>
                <c:pt idx="15">
                  <c:v>0.709176476</c:v>
                </c:pt>
                <c:pt idx="20">
                  <c:v>0.62700102599999996</c:v>
                </c:pt>
                <c:pt idx="26">
                  <c:v>0.50369440899999995</c:v>
                </c:pt>
                <c:pt idx="31">
                  <c:v>0.637478455</c:v>
                </c:pt>
                <c:pt idx="35">
                  <c:v>0.65151808300000003</c:v>
                </c:pt>
                <c:pt idx="39">
                  <c:v>0.651843269</c:v>
                </c:pt>
                <c:pt idx="40">
                  <c:v>0.65379437799999995</c:v>
                </c:pt>
              </c:numCache>
            </c:numRef>
          </c:yVal>
          <c:smooth val="0"/>
        </c:ser>
        <c:ser>
          <c:idx val="3"/>
          <c:order val="3"/>
          <c:tx>
            <c:strRef>
              <c:f>ngsRelate2!$O$21</c:f>
              <c:strCache>
                <c:ptCount val="1"/>
                <c:pt idx="0">
                  <c:v>IBL-IBL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ngsRelate2!$D$22:$D$66</c:f>
              <c:numCache>
                <c:formatCode>General</c:formatCode>
                <c:ptCount val="45"/>
                <c:pt idx="0">
                  <c:v>0.46544200000000002</c:v>
                </c:pt>
                <c:pt idx="1">
                  <c:v>0.41791499999999998</c:v>
                </c:pt>
                <c:pt idx="2">
                  <c:v>0.39836300000000002</c:v>
                </c:pt>
                <c:pt idx="3">
                  <c:v>0.418236</c:v>
                </c:pt>
                <c:pt idx="4">
                  <c:v>0.42063200000000001</c:v>
                </c:pt>
                <c:pt idx="5">
                  <c:v>0.50950200000000001</c:v>
                </c:pt>
                <c:pt idx="6">
                  <c:v>0.26186300000000001</c:v>
                </c:pt>
                <c:pt idx="7">
                  <c:v>0.42806300000000003</c:v>
                </c:pt>
                <c:pt idx="8">
                  <c:v>0.51772600000000002</c:v>
                </c:pt>
                <c:pt idx="9">
                  <c:v>0.61347399999999996</c:v>
                </c:pt>
                <c:pt idx="10">
                  <c:v>0.50597400000000003</c:v>
                </c:pt>
                <c:pt idx="11">
                  <c:v>0.50970899999999997</c:v>
                </c:pt>
                <c:pt idx="12">
                  <c:v>0.51433200000000001</c:v>
                </c:pt>
                <c:pt idx="13">
                  <c:v>0.52567200000000003</c:v>
                </c:pt>
                <c:pt idx="14">
                  <c:v>0.29619699999999999</c:v>
                </c:pt>
                <c:pt idx="15">
                  <c:v>0.51184700000000005</c:v>
                </c:pt>
                <c:pt idx="16">
                  <c:v>0.47953499999999999</c:v>
                </c:pt>
                <c:pt idx="17">
                  <c:v>0.60518000000000005</c:v>
                </c:pt>
                <c:pt idx="18">
                  <c:v>0.57027600000000001</c:v>
                </c:pt>
                <c:pt idx="19">
                  <c:v>0.57694299999999998</c:v>
                </c:pt>
                <c:pt idx="20">
                  <c:v>0.457457</c:v>
                </c:pt>
                <c:pt idx="21">
                  <c:v>0.34354699999999999</c:v>
                </c:pt>
                <c:pt idx="22">
                  <c:v>0.55021399999999998</c:v>
                </c:pt>
                <c:pt idx="23">
                  <c:v>0.423983</c:v>
                </c:pt>
                <c:pt idx="24">
                  <c:v>0.78660600000000003</c:v>
                </c:pt>
                <c:pt idx="25">
                  <c:v>0.79294699999999996</c:v>
                </c:pt>
                <c:pt idx="26">
                  <c:v>0.43724299999999999</c:v>
                </c:pt>
                <c:pt idx="27">
                  <c:v>0.47153699999999998</c:v>
                </c:pt>
                <c:pt idx="28">
                  <c:v>0.72457000000000005</c:v>
                </c:pt>
                <c:pt idx="29">
                  <c:v>0.39781</c:v>
                </c:pt>
                <c:pt idx="30">
                  <c:v>0.92727599999999999</c:v>
                </c:pt>
                <c:pt idx="31">
                  <c:v>0.46523900000000001</c:v>
                </c:pt>
                <c:pt idx="32">
                  <c:v>0.45355600000000001</c:v>
                </c:pt>
                <c:pt idx="33">
                  <c:v>0.75563599999999997</c:v>
                </c:pt>
                <c:pt idx="34">
                  <c:v>0.42865999999999999</c:v>
                </c:pt>
                <c:pt idx="35">
                  <c:v>0.46783000000000002</c:v>
                </c:pt>
                <c:pt idx="36">
                  <c:v>0.45271299999999998</c:v>
                </c:pt>
                <c:pt idx="37">
                  <c:v>0.76128200000000001</c:v>
                </c:pt>
                <c:pt idx="38">
                  <c:v>0.425429</c:v>
                </c:pt>
                <c:pt idx="39">
                  <c:v>0.28205599999999997</c:v>
                </c:pt>
                <c:pt idx="40">
                  <c:v>0.47584599999999999</c:v>
                </c:pt>
                <c:pt idx="41">
                  <c:v>0.52213799999999999</c:v>
                </c:pt>
                <c:pt idx="42">
                  <c:v>0.56401800000000002</c:v>
                </c:pt>
                <c:pt idx="43">
                  <c:v>0.26060699999999998</c:v>
                </c:pt>
                <c:pt idx="44">
                  <c:v>0.43262899999999999</c:v>
                </c:pt>
              </c:numCache>
            </c:numRef>
          </c:xVal>
          <c:yVal>
            <c:numRef>
              <c:f>ngsRelate2!$O$22:$O$66</c:f>
              <c:numCache>
                <c:formatCode>General</c:formatCode>
                <c:ptCount val="45"/>
                <c:pt idx="8">
                  <c:v>0.86811666499999995</c:v>
                </c:pt>
              </c:numCache>
            </c:numRef>
          </c:yVal>
          <c:smooth val="0"/>
        </c:ser>
        <c:ser>
          <c:idx val="4"/>
          <c:order val="4"/>
          <c:tx>
            <c:strRef>
              <c:f>ngsRelate2!$P$21</c:f>
              <c:strCache>
                <c:ptCount val="1"/>
                <c:pt idx="0">
                  <c:v>IBL-MFIBL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ngsRelate2!$D$22:$D$66</c:f>
              <c:numCache>
                <c:formatCode>General</c:formatCode>
                <c:ptCount val="45"/>
                <c:pt idx="0">
                  <c:v>0.46544200000000002</c:v>
                </c:pt>
                <c:pt idx="1">
                  <c:v>0.41791499999999998</c:v>
                </c:pt>
                <c:pt idx="2">
                  <c:v>0.39836300000000002</c:v>
                </c:pt>
                <c:pt idx="3">
                  <c:v>0.418236</c:v>
                </c:pt>
                <c:pt idx="4">
                  <c:v>0.42063200000000001</c:v>
                </c:pt>
                <c:pt idx="5">
                  <c:v>0.50950200000000001</c:v>
                </c:pt>
                <c:pt idx="6">
                  <c:v>0.26186300000000001</c:v>
                </c:pt>
                <c:pt idx="7">
                  <c:v>0.42806300000000003</c:v>
                </c:pt>
                <c:pt idx="8">
                  <c:v>0.51772600000000002</c:v>
                </c:pt>
                <c:pt idx="9">
                  <c:v>0.61347399999999996</c:v>
                </c:pt>
                <c:pt idx="10">
                  <c:v>0.50597400000000003</c:v>
                </c:pt>
                <c:pt idx="11">
                  <c:v>0.50970899999999997</c:v>
                </c:pt>
                <c:pt idx="12">
                  <c:v>0.51433200000000001</c:v>
                </c:pt>
                <c:pt idx="13">
                  <c:v>0.52567200000000003</c:v>
                </c:pt>
                <c:pt idx="14">
                  <c:v>0.29619699999999999</c:v>
                </c:pt>
                <c:pt idx="15">
                  <c:v>0.51184700000000005</c:v>
                </c:pt>
                <c:pt idx="16">
                  <c:v>0.47953499999999999</c:v>
                </c:pt>
                <c:pt idx="17">
                  <c:v>0.60518000000000005</c:v>
                </c:pt>
                <c:pt idx="18">
                  <c:v>0.57027600000000001</c:v>
                </c:pt>
                <c:pt idx="19">
                  <c:v>0.57694299999999998</c:v>
                </c:pt>
                <c:pt idx="20">
                  <c:v>0.457457</c:v>
                </c:pt>
                <c:pt idx="21">
                  <c:v>0.34354699999999999</c:v>
                </c:pt>
                <c:pt idx="22">
                  <c:v>0.55021399999999998</c:v>
                </c:pt>
                <c:pt idx="23">
                  <c:v>0.423983</c:v>
                </c:pt>
                <c:pt idx="24">
                  <c:v>0.78660600000000003</c:v>
                </c:pt>
                <c:pt idx="25">
                  <c:v>0.79294699999999996</c:v>
                </c:pt>
                <c:pt idx="26">
                  <c:v>0.43724299999999999</c:v>
                </c:pt>
                <c:pt idx="27">
                  <c:v>0.47153699999999998</c:v>
                </c:pt>
                <c:pt idx="28">
                  <c:v>0.72457000000000005</c:v>
                </c:pt>
                <c:pt idx="29">
                  <c:v>0.39781</c:v>
                </c:pt>
                <c:pt idx="30">
                  <c:v>0.92727599999999999</c:v>
                </c:pt>
                <c:pt idx="31">
                  <c:v>0.46523900000000001</c:v>
                </c:pt>
                <c:pt idx="32">
                  <c:v>0.45355600000000001</c:v>
                </c:pt>
                <c:pt idx="33">
                  <c:v>0.75563599999999997</c:v>
                </c:pt>
                <c:pt idx="34">
                  <c:v>0.42865999999999999</c:v>
                </c:pt>
                <c:pt idx="35">
                  <c:v>0.46783000000000002</c:v>
                </c:pt>
                <c:pt idx="36">
                  <c:v>0.45271299999999998</c:v>
                </c:pt>
                <c:pt idx="37">
                  <c:v>0.76128200000000001</c:v>
                </c:pt>
                <c:pt idx="38">
                  <c:v>0.425429</c:v>
                </c:pt>
                <c:pt idx="39">
                  <c:v>0.28205599999999997</c:v>
                </c:pt>
                <c:pt idx="40">
                  <c:v>0.47584599999999999</c:v>
                </c:pt>
                <c:pt idx="41">
                  <c:v>0.52213799999999999</c:v>
                </c:pt>
                <c:pt idx="42">
                  <c:v>0.56401800000000002</c:v>
                </c:pt>
                <c:pt idx="43">
                  <c:v>0.26060699999999998</c:v>
                </c:pt>
                <c:pt idx="44">
                  <c:v>0.43262899999999999</c:v>
                </c:pt>
              </c:numCache>
            </c:numRef>
          </c:xVal>
          <c:yVal>
            <c:numRef>
              <c:f>ngsRelate2!$P$22:$P$66</c:f>
              <c:numCache>
                <c:formatCode>General</c:formatCode>
                <c:ptCount val="45"/>
                <c:pt idx="0">
                  <c:v>0.78937368100000005</c:v>
                </c:pt>
                <c:pt idx="5">
                  <c:v>0.78437788399999997</c:v>
                </c:pt>
                <c:pt idx="16">
                  <c:v>0.78491698799999998</c:v>
                </c:pt>
                <c:pt idx="41">
                  <c:v>0.82904657900000001</c:v>
                </c:pt>
              </c:numCache>
            </c:numRef>
          </c:yVal>
          <c:smooth val="0"/>
        </c:ser>
        <c:ser>
          <c:idx val="5"/>
          <c:order val="5"/>
          <c:tx>
            <c:strRef>
              <c:f>ngsRelate2!$Q$21</c:f>
              <c:strCache>
                <c:ptCount val="1"/>
                <c:pt idx="0">
                  <c:v>MFIBL-MFIBL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ngsRelate2!$D$22:$D$66</c:f>
              <c:numCache>
                <c:formatCode>General</c:formatCode>
                <c:ptCount val="45"/>
                <c:pt idx="0">
                  <c:v>0.46544200000000002</c:v>
                </c:pt>
                <c:pt idx="1">
                  <c:v>0.41791499999999998</c:v>
                </c:pt>
                <c:pt idx="2">
                  <c:v>0.39836300000000002</c:v>
                </c:pt>
                <c:pt idx="3">
                  <c:v>0.418236</c:v>
                </c:pt>
                <c:pt idx="4">
                  <c:v>0.42063200000000001</c:v>
                </c:pt>
                <c:pt idx="5">
                  <c:v>0.50950200000000001</c:v>
                </c:pt>
                <c:pt idx="6">
                  <c:v>0.26186300000000001</c:v>
                </c:pt>
                <c:pt idx="7">
                  <c:v>0.42806300000000003</c:v>
                </c:pt>
                <c:pt idx="8">
                  <c:v>0.51772600000000002</c:v>
                </c:pt>
                <c:pt idx="9">
                  <c:v>0.61347399999999996</c:v>
                </c:pt>
                <c:pt idx="10">
                  <c:v>0.50597400000000003</c:v>
                </c:pt>
                <c:pt idx="11">
                  <c:v>0.50970899999999997</c:v>
                </c:pt>
                <c:pt idx="12">
                  <c:v>0.51433200000000001</c:v>
                </c:pt>
                <c:pt idx="13">
                  <c:v>0.52567200000000003</c:v>
                </c:pt>
                <c:pt idx="14">
                  <c:v>0.29619699999999999</c:v>
                </c:pt>
                <c:pt idx="15">
                  <c:v>0.51184700000000005</c:v>
                </c:pt>
                <c:pt idx="16">
                  <c:v>0.47953499999999999</c:v>
                </c:pt>
                <c:pt idx="17">
                  <c:v>0.60518000000000005</c:v>
                </c:pt>
                <c:pt idx="18">
                  <c:v>0.57027600000000001</c:v>
                </c:pt>
                <c:pt idx="19">
                  <c:v>0.57694299999999998</c:v>
                </c:pt>
                <c:pt idx="20">
                  <c:v>0.457457</c:v>
                </c:pt>
                <c:pt idx="21">
                  <c:v>0.34354699999999999</c:v>
                </c:pt>
                <c:pt idx="22">
                  <c:v>0.55021399999999998</c:v>
                </c:pt>
                <c:pt idx="23">
                  <c:v>0.423983</c:v>
                </c:pt>
                <c:pt idx="24">
                  <c:v>0.78660600000000003</c:v>
                </c:pt>
                <c:pt idx="25">
                  <c:v>0.79294699999999996</c:v>
                </c:pt>
                <c:pt idx="26">
                  <c:v>0.43724299999999999</c:v>
                </c:pt>
                <c:pt idx="27">
                  <c:v>0.47153699999999998</c:v>
                </c:pt>
                <c:pt idx="28">
                  <c:v>0.72457000000000005</c:v>
                </c:pt>
                <c:pt idx="29">
                  <c:v>0.39781</c:v>
                </c:pt>
                <c:pt idx="30">
                  <c:v>0.92727599999999999</c:v>
                </c:pt>
                <c:pt idx="31">
                  <c:v>0.46523900000000001</c:v>
                </c:pt>
                <c:pt idx="32">
                  <c:v>0.45355600000000001</c:v>
                </c:pt>
                <c:pt idx="33">
                  <c:v>0.75563599999999997</c:v>
                </c:pt>
                <c:pt idx="34">
                  <c:v>0.42865999999999999</c:v>
                </c:pt>
                <c:pt idx="35">
                  <c:v>0.46783000000000002</c:v>
                </c:pt>
                <c:pt idx="36">
                  <c:v>0.45271299999999998</c:v>
                </c:pt>
                <c:pt idx="37">
                  <c:v>0.76128200000000001</c:v>
                </c:pt>
                <c:pt idx="38">
                  <c:v>0.425429</c:v>
                </c:pt>
                <c:pt idx="39">
                  <c:v>0.28205599999999997</c:v>
                </c:pt>
                <c:pt idx="40">
                  <c:v>0.47584599999999999</c:v>
                </c:pt>
                <c:pt idx="41">
                  <c:v>0.52213799999999999</c:v>
                </c:pt>
                <c:pt idx="42">
                  <c:v>0.56401800000000002</c:v>
                </c:pt>
                <c:pt idx="43">
                  <c:v>0.26060699999999998</c:v>
                </c:pt>
                <c:pt idx="44">
                  <c:v>0.43262899999999999</c:v>
                </c:pt>
              </c:numCache>
            </c:numRef>
          </c:xVal>
          <c:yVal>
            <c:numRef>
              <c:f>ngsRelate2!$Q$22:$Q$66</c:f>
              <c:numCache>
                <c:formatCode>General</c:formatCode>
                <c:ptCount val="45"/>
                <c:pt idx="13">
                  <c:v>0.91578452899999996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2433136"/>
        <c:axId val="112359368"/>
      </c:scatterChart>
      <c:valAx>
        <c:axId val="9243313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,##0.0_);[Red]\(#,##0.0\)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defRPr>
            </a:pPr>
            <a:endParaRPr lang="ja-JP"/>
          </a:p>
        </c:txPr>
        <c:crossAx val="112359368"/>
        <c:crosses val="autoZero"/>
        <c:crossBetween val="midCat"/>
      </c:valAx>
      <c:valAx>
        <c:axId val="112359368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,##0.0_);[Red]\(#,##0.0\)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defRPr>
            </a:pPr>
            <a:endParaRPr lang="ja-JP"/>
          </a:p>
        </c:txPr>
        <c:crossAx val="92433136"/>
        <c:crosses val="autoZero"/>
        <c:crossBetween val="midCat"/>
        <c:majorUnit val="0.2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1687450497111727"/>
          <c:y val="0.88173072653777906"/>
          <c:w val="0.79018937104895792"/>
          <c:h val="0.118269273462220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4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400">
          <a:latin typeface="メイリオ" panose="020B0604030504040204" pitchFamily="50" charset="-128"/>
          <a:ea typeface="メイリオ" panose="020B0604030504040204" pitchFamily="50" charset="-128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6AAE286-D8FB-4E18-B071-7DF244592A68}" type="datetimeFigureOut">
              <a:rPr kumimoji="1" lang="ja-JP" altLang="en-US" smtClean="0"/>
              <a:t>2020/11/1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B479ED1-DDFC-448B-92E6-D16FE68C46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46058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B479ED1-DDFC-448B-92E6-D16FE68C4662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877172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298BF-D1EC-4EA5-AC1A-49BC0950E7B1}" type="datetimeFigureOut">
              <a:rPr kumimoji="1" lang="ja-JP" altLang="en-US" smtClean="0"/>
              <a:t>2020/1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513CC-E8B2-4DC3-B6C0-314A9C708D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99790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298BF-D1EC-4EA5-AC1A-49BC0950E7B1}" type="datetimeFigureOut">
              <a:rPr kumimoji="1" lang="ja-JP" altLang="en-US" smtClean="0"/>
              <a:t>2020/1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513CC-E8B2-4DC3-B6C0-314A9C708D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81495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298BF-D1EC-4EA5-AC1A-49BC0950E7B1}" type="datetimeFigureOut">
              <a:rPr kumimoji="1" lang="ja-JP" altLang="en-US" smtClean="0"/>
              <a:t>2020/1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513CC-E8B2-4DC3-B6C0-314A9C708D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42936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298BF-D1EC-4EA5-AC1A-49BC0950E7B1}" type="datetimeFigureOut">
              <a:rPr kumimoji="1" lang="ja-JP" altLang="en-US" smtClean="0"/>
              <a:t>2020/1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513CC-E8B2-4DC3-B6C0-314A9C708D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26733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298BF-D1EC-4EA5-AC1A-49BC0950E7B1}" type="datetimeFigureOut">
              <a:rPr kumimoji="1" lang="ja-JP" altLang="en-US" smtClean="0"/>
              <a:t>2020/1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513CC-E8B2-4DC3-B6C0-314A9C708D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23591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298BF-D1EC-4EA5-AC1A-49BC0950E7B1}" type="datetimeFigureOut">
              <a:rPr kumimoji="1" lang="ja-JP" altLang="en-US" smtClean="0"/>
              <a:t>2020/11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513CC-E8B2-4DC3-B6C0-314A9C708D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67336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298BF-D1EC-4EA5-AC1A-49BC0950E7B1}" type="datetimeFigureOut">
              <a:rPr kumimoji="1" lang="ja-JP" altLang="en-US" smtClean="0"/>
              <a:t>2020/11/1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513CC-E8B2-4DC3-B6C0-314A9C708D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5845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298BF-D1EC-4EA5-AC1A-49BC0950E7B1}" type="datetimeFigureOut">
              <a:rPr kumimoji="1" lang="ja-JP" altLang="en-US" smtClean="0"/>
              <a:t>2020/11/1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513CC-E8B2-4DC3-B6C0-314A9C708D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35441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298BF-D1EC-4EA5-AC1A-49BC0950E7B1}" type="datetimeFigureOut">
              <a:rPr kumimoji="1" lang="ja-JP" altLang="en-US" smtClean="0"/>
              <a:t>2020/11/1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513CC-E8B2-4DC3-B6C0-314A9C708D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26036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298BF-D1EC-4EA5-AC1A-49BC0950E7B1}" type="datetimeFigureOut">
              <a:rPr kumimoji="1" lang="ja-JP" altLang="en-US" smtClean="0"/>
              <a:t>2020/11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513CC-E8B2-4DC3-B6C0-314A9C708D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13468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298BF-D1EC-4EA5-AC1A-49BC0950E7B1}" type="datetimeFigureOut">
              <a:rPr kumimoji="1" lang="ja-JP" altLang="en-US" smtClean="0"/>
              <a:t>2020/11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513CC-E8B2-4DC3-B6C0-314A9C708D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38288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C298BF-D1EC-4EA5-AC1A-49BC0950E7B1}" type="datetimeFigureOut">
              <a:rPr kumimoji="1" lang="ja-JP" altLang="en-US" smtClean="0"/>
              <a:t>2020/1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3513CC-E8B2-4DC3-B6C0-314A9C708D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83229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02514910"/>
              </p:ext>
            </p:extLst>
          </p:nvPr>
        </p:nvGraphicFramePr>
        <p:xfrm>
          <a:off x="1322524" y="921110"/>
          <a:ext cx="6642340" cy="49084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正方形/長方形 3"/>
          <p:cNvSpPr/>
          <p:nvPr/>
        </p:nvSpPr>
        <p:spPr>
          <a:xfrm>
            <a:off x="3602158" y="4691654"/>
            <a:ext cx="165942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dirty="0" smtClean="0">
                <a:latin typeface="メイリオ" panose="020B0604030504040204" pitchFamily="50" charset="-128"/>
                <a:ea typeface="メイリオ" panose="020B0604030504040204" pitchFamily="50" charset="-128"/>
                <a:cs typeface="Times New Roman" panose="02020603050405020304" pitchFamily="18" charset="0"/>
              </a:rPr>
              <a:t>Relatedness (</a:t>
            </a:r>
            <a:r>
              <a:rPr lang="en-US" altLang="ja-JP" sz="1400" i="1" dirty="0" err="1" smtClean="0">
                <a:latin typeface="メイリオ" panose="020B0604030504040204" pitchFamily="50" charset="-128"/>
                <a:ea typeface="メイリオ" panose="020B0604030504040204" pitchFamily="50" charset="-128"/>
                <a:cs typeface="Times New Roman" panose="02020603050405020304" pitchFamily="18" charset="0"/>
              </a:rPr>
              <a:t>r</a:t>
            </a:r>
            <a:r>
              <a:rPr lang="en-US" altLang="ja-JP" sz="1400" i="1" baseline="-25000" dirty="0" err="1" smtClean="0">
                <a:latin typeface="メイリオ" panose="020B0604030504040204" pitchFamily="50" charset="-128"/>
                <a:ea typeface="メイリオ" panose="020B0604030504040204" pitchFamily="50" charset="-128"/>
                <a:cs typeface="Times New Roman" panose="02020603050405020304" pitchFamily="18" charset="0"/>
              </a:rPr>
              <a:t>xy</a:t>
            </a:r>
            <a:r>
              <a:rPr lang="en-US" altLang="ja-JP" sz="1400" dirty="0" smtClean="0">
                <a:latin typeface="メイリオ" panose="020B0604030504040204" pitchFamily="50" charset="-128"/>
                <a:ea typeface="メイリオ" panose="020B0604030504040204" pitchFamily="50" charset="-128"/>
                <a:cs typeface="Times New Roman" panose="02020603050405020304" pitchFamily="18" charset="0"/>
              </a:rPr>
              <a:t>)</a:t>
            </a:r>
            <a:endParaRPr lang="ja-JP" altLang="en-US" sz="1400" dirty="0">
              <a:latin typeface="メイリオ" panose="020B0604030504040204" pitchFamily="50" charset="-128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5" name="正方形/長方形 4"/>
          <p:cNvSpPr/>
          <p:nvPr/>
        </p:nvSpPr>
        <p:spPr>
          <a:xfrm rot="16200000">
            <a:off x="-429456" y="2251927"/>
            <a:ext cx="2665859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400" dirty="0" smtClean="0">
                <a:latin typeface="メイリオ" panose="020B0604030504040204" pitchFamily="50" charset="-128"/>
                <a:ea typeface="メイリオ" panose="020B0604030504040204" pitchFamily="50" charset="-128"/>
                <a:cs typeface="Times New Roman" panose="02020603050405020304" pitchFamily="18" charset="0"/>
              </a:rPr>
              <a:t> Pearson’s product-moment </a:t>
            </a:r>
          </a:p>
          <a:p>
            <a:pPr algn="ctr"/>
            <a:r>
              <a:rPr lang="en-US" altLang="ja-JP" sz="1400" dirty="0" smtClean="0">
                <a:latin typeface="メイリオ" panose="020B0604030504040204" pitchFamily="50" charset="-128"/>
                <a:ea typeface="メイリオ" panose="020B0604030504040204" pitchFamily="50" charset="-128"/>
                <a:cs typeface="Times New Roman" panose="02020603050405020304" pitchFamily="18" charset="0"/>
              </a:rPr>
              <a:t>correlation coefficient </a:t>
            </a:r>
            <a:endParaRPr lang="ja-JP" altLang="en-US" sz="1400" dirty="0">
              <a:latin typeface="メイリオ" panose="020B0604030504040204" pitchFamily="50" charset="-128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121512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753</TotalTime>
  <Words>10</Words>
  <Application>Microsoft Office PowerPoint</Application>
  <PresentationFormat>On-screen Show (4:3)</PresentationFormat>
  <Paragraphs>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ＭＳ Ｐゴシック</vt:lpstr>
      <vt:lpstr>メイリオ</vt:lpstr>
      <vt:lpstr>Arial</vt:lpstr>
      <vt:lpstr>Calibri</vt:lpstr>
      <vt:lpstr>Calibri Light</vt:lpstr>
      <vt:lpstr>Times New Roman</vt:lpstr>
      <vt:lpstr>Office テーマ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aneyoshi Ueno</dc:creator>
  <cp:lastModifiedBy>Saneyoshi Ueno</cp:lastModifiedBy>
  <cp:revision>45</cp:revision>
  <dcterms:created xsi:type="dcterms:W3CDTF">2020-09-07T08:43:57Z</dcterms:created>
  <dcterms:modified xsi:type="dcterms:W3CDTF">2020-11-12T03:04:52Z</dcterms:modified>
</cp:coreProperties>
</file>